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9" r:id="rId4"/>
    <p:sldId id="262" r:id="rId5"/>
    <p:sldId id="264" r:id="rId6"/>
    <p:sldId id="263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82"/>
  </p:normalViewPr>
  <p:slideViewPr>
    <p:cSldViewPr>
      <p:cViewPr>
        <p:scale>
          <a:sx n="80" d="100"/>
          <a:sy n="80" d="100"/>
        </p:scale>
        <p:origin x="-1752" y="46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33003-9F01-4800-9ED3-AE3E8E1F014D}" type="datetimeFigureOut">
              <a:rPr lang="en-GB" smtClean="0"/>
              <a:pPr/>
              <a:t>23/08/2022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A2839B-61B0-4F23-B99E-E4ED0BDFA4B7}" type="slidenum">
              <a:rPr lang="en-GB" smtClean="0"/>
              <a:pPr/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31.png"/><Relationship Id="rId18" Type="http://schemas.openxmlformats.org/officeDocument/2006/relationships/image" Target="../media/image36.png"/><Relationship Id="rId3" Type="http://schemas.openxmlformats.org/officeDocument/2006/relationships/image" Target="../media/image21.png"/><Relationship Id="rId21" Type="http://schemas.openxmlformats.org/officeDocument/2006/relationships/image" Target="../media/image39.png"/><Relationship Id="rId7" Type="http://schemas.openxmlformats.org/officeDocument/2006/relationships/image" Target="../media/image25.png"/><Relationship Id="rId12" Type="http://schemas.openxmlformats.org/officeDocument/2006/relationships/image" Target="../media/image30.png"/><Relationship Id="rId17" Type="http://schemas.openxmlformats.org/officeDocument/2006/relationships/image" Target="../media/image35.png"/><Relationship Id="rId2" Type="http://schemas.openxmlformats.org/officeDocument/2006/relationships/image" Target="../media/image20.png"/><Relationship Id="rId16" Type="http://schemas.openxmlformats.org/officeDocument/2006/relationships/image" Target="../media/image34.png"/><Relationship Id="rId20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24" Type="http://schemas.openxmlformats.org/officeDocument/2006/relationships/image" Target="../media/image42.png"/><Relationship Id="rId5" Type="http://schemas.openxmlformats.org/officeDocument/2006/relationships/image" Target="../media/image23.png"/><Relationship Id="rId15" Type="http://schemas.openxmlformats.org/officeDocument/2006/relationships/image" Target="../media/image33.png"/><Relationship Id="rId23" Type="http://schemas.openxmlformats.org/officeDocument/2006/relationships/image" Target="../media/image41.png"/><Relationship Id="rId10" Type="http://schemas.openxmlformats.org/officeDocument/2006/relationships/image" Target="../media/image28.png"/><Relationship Id="rId19" Type="http://schemas.openxmlformats.org/officeDocument/2006/relationships/image" Target="../media/image37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Relationship Id="rId14" Type="http://schemas.openxmlformats.org/officeDocument/2006/relationships/image" Target="../media/image32.png"/><Relationship Id="rId22" Type="http://schemas.openxmlformats.org/officeDocument/2006/relationships/image" Target="../media/image4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752279" y="1115616"/>
            <a:ext cx="3061097" cy="33843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34635" y="1115616"/>
            <a:ext cx="3061097" cy="33843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8" name="Tabella 7"/>
          <p:cNvGraphicFramePr>
            <a:graphicFrameLocks noGrp="1"/>
          </p:cNvGraphicFramePr>
          <p:nvPr/>
        </p:nvGraphicFramePr>
        <p:xfrm>
          <a:off x="512676" y="3373120"/>
          <a:ext cx="2700300" cy="113792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7507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675075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675075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675075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284480"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84480"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84480"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25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84480"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9" name="CasellaDiTesto 8"/>
          <p:cNvSpPr txBox="1"/>
          <p:nvPr/>
        </p:nvSpPr>
        <p:spPr>
          <a:xfrm>
            <a:off x="1592796" y="1307638"/>
            <a:ext cx="145816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>
                <a:latin typeface="Arial" pitchFamily="34" charset="0"/>
                <a:cs typeface="Arial" pitchFamily="34" charset="0"/>
              </a:rPr>
              <a:t>Log-rank</a:t>
            </a:r>
            <a:r>
              <a:rPr lang="it-IT" sz="1100" dirty="0">
                <a:latin typeface="Arial" pitchFamily="34" charset="0"/>
                <a:cs typeface="Arial" pitchFamily="34" charset="0"/>
              </a:rPr>
              <a:t> test p&lt;0.0001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5373216" y="1307638"/>
            <a:ext cx="145816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>
                <a:latin typeface="Arial" pitchFamily="34" charset="0"/>
                <a:cs typeface="Arial" pitchFamily="34" charset="0"/>
              </a:rPr>
              <a:t>Log-rank</a:t>
            </a:r>
            <a:r>
              <a:rPr lang="it-IT" sz="1100" dirty="0">
                <a:latin typeface="Arial" pitchFamily="34" charset="0"/>
                <a:cs typeface="Arial" pitchFamily="34" charset="0"/>
              </a:rPr>
              <a:t> test p&lt;0.0001</a:t>
            </a:r>
          </a:p>
        </p:txBody>
      </p:sp>
      <p:graphicFrame>
        <p:nvGraphicFramePr>
          <p:cNvPr id="13" name="Tabella 12"/>
          <p:cNvGraphicFramePr>
            <a:graphicFrameLocks noGrp="1"/>
          </p:cNvGraphicFramePr>
          <p:nvPr/>
        </p:nvGraphicFramePr>
        <p:xfrm>
          <a:off x="4185084" y="3347864"/>
          <a:ext cx="2700300" cy="113792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7507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675075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675075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675075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284480"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84480"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84480"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25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84480"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6" name="CasellaDiTesto 15"/>
          <p:cNvSpPr txBox="1"/>
          <p:nvPr/>
        </p:nvSpPr>
        <p:spPr>
          <a:xfrm>
            <a:off x="1268760" y="683568"/>
            <a:ext cx="810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>
                <a:latin typeface="Arial" pitchFamily="34" charset="0"/>
                <a:cs typeface="Arial" pitchFamily="34" charset="0"/>
              </a:rPr>
              <a:t>PFS</a:t>
            </a:r>
          </a:p>
        </p:txBody>
      </p:sp>
      <p:sp>
        <p:nvSpPr>
          <p:cNvPr id="17" name="CasellaDiTesto 16"/>
          <p:cNvSpPr txBox="1"/>
          <p:nvPr/>
        </p:nvSpPr>
        <p:spPr>
          <a:xfrm>
            <a:off x="4941168" y="683568"/>
            <a:ext cx="810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>
                <a:latin typeface="Arial" pitchFamily="34" charset="0"/>
                <a:cs typeface="Arial" pitchFamily="34" charset="0"/>
              </a:rPr>
              <a:t>OS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5301208" y="8774668"/>
            <a:ext cx="1539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.Figure</a:t>
            </a:r>
            <a:r>
              <a:rPr lang="it-IT" b="1" dirty="0"/>
              <a:t> 1</a:t>
            </a:r>
            <a:endParaRPr lang="en-GB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5301208" y="8774668"/>
            <a:ext cx="1539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.Figure</a:t>
            </a:r>
            <a:r>
              <a:rPr lang="it-IT" b="1" dirty="0"/>
              <a:t> 2</a:t>
            </a:r>
            <a:endParaRPr lang="en-GB" b="1" dirty="0"/>
          </a:p>
        </p:txBody>
      </p:sp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86572" y="4428224"/>
            <a:ext cx="4326804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4624" y="4428224"/>
            <a:ext cx="2423349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CasellaDiTesto 5"/>
          <p:cNvSpPr txBox="1"/>
          <p:nvPr/>
        </p:nvSpPr>
        <p:spPr>
          <a:xfrm>
            <a:off x="-44800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A</a:t>
            </a:r>
            <a:endParaRPr lang="en-GB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-54680" y="219573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B</a:t>
            </a:r>
            <a:endParaRPr lang="en-GB" b="1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-27384" y="650692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D</a:t>
            </a:r>
            <a:endParaRPr lang="en-GB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212749" y="2339952"/>
            <a:ext cx="1360267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149080" y="2339952"/>
            <a:ext cx="1354397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20688" y="2339952"/>
            <a:ext cx="1354397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76672" y="6516216"/>
            <a:ext cx="1786154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CasellaDiTesto 12"/>
          <p:cNvSpPr txBox="1"/>
          <p:nvPr/>
        </p:nvSpPr>
        <p:spPr>
          <a:xfrm>
            <a:off x="-27384" y="420266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C</a:t>
            </a:r>
            <a:endParaRPr lang="en-GB" b="1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12587" y="251520"/>
            <a:ext cx="1336634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240779" y="251520"/>
            <a:ext cx="132039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" name="Picture 4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4040979" y="251520"/>
            <a:ext cx="1332237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5301208" y="8774668"/>
            <a:ext cx="1539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.Figure</a:t>
            </a:r>
            <a:r>
              <a:rPr lang="it-IT" b="1" dirty="0"/>
              <a:t> 3</a:t>
            </a:r>
            <a:endParaRPr lang="en-GB" b="1" dirty="0"/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30609" y="3564112"/>
            <a:ext cx="2262287" cy="2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630306" y="3492104"/>
            <a:ext cx="4183070" cy="2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18637" y="6012400"/>
            <a:ext cx="4926769" cy="19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CasellaDiTesto 5"/>
          <p:cNvSpPr txBox="1"/>
          <p:nvPr/>
        </p:nvSpPr>
        <p:spPr>
          <a:xfrm>
            <a:off x="-27384" y="326656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B</a:t>
            </a:r>
            <a:endParaRPr lang="en-GB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-2876" y="10750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A</a:t>
            </a:r>
            <a:endParaRPr lang="en-GB" b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60648" y="179512"/>
            <a:ext cx="1876923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411606" y="179512"/>
            <a:ext cx="188149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581128" y="179512"/>
            <a:ext cx="1856629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50"/>
          <p:cNvGrpSpPr/>
          <p:nvPr/>
        </p:nvGrpSpPr>
        <p:grpSpPr>
          <a:xfrm>
            <a:off x="1268760" y="-35496"/>
            <a:ext cx="3991520" cy="8892480"/>
            <a:chOff x="1340767" y="1979712"/>
            <a:chExt cx="4149081" cy="6768752"/>
          </a:xfrm>
        </p:grpSpPr>
        <p:sp>
          <p:nvSpPr>
            <p:cNvPr id="33" name="CasellaDiTesto 32"/>
            <p:cNvSpPr txBox="1"/>
            <p:nvPr/>
          </p:nvSpPr>
          <p:spPr>
            <a:xfrm>
              <a:off x="4481736" y="1979712"/>
              <a:ext cx="1008112" cy="4419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CD4</a:t>
              </a:r>
            </a:p>
            <a:p>
              <a:pPr algn="ctr"/>
              <a:endParaRPr lang="it-IT" sz="1000" b="1" dirty="0"/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1340767" y="1979712"/>
              <a:ext cx="1008112" cy="4419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CD8</a:t>
              </a:r>
            </a:p>
            <a:p>
              <a:pPr algn="ctr"/>
              <a:endParaRPr lang="it-IT" sz="1000" b="1" dirty="0"/>
            </a:p>
          </p:txBody>
        </p:sp>
        <p:cxnSp>
          <p:nvCxnSpPr>
            <p:cNvPr id="50" name="Straight Connector 26"/>
            <p:cNvCxnSpPr/>
            <p:nvPr/>
          </p:nvCxnSpPr>
          <p:spPr>
            <a:xfrm>
              <a:off x="3284984" y="2123728"/>
              <a:ext cx="0" cy="6624736"/>
            </a:xfrm>
            <a:prstGeom prst="line">
              <a:avLst/>
            </a:prstGeom>
            <a:ln w="19050" cmpd="sng">
              <a:solidFill>
                <a:schemeClr val="tx1"/>
              </a:solidFill>
              <a:prstDash val="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" name="CasellaDiTesto 7"/>
          <p:cNvSpPr txBox="1"/>
          <p:nvPr/>
        </p:nvSpPr>
        <p:spPr>
          <a:xfrm>
            <a:off x="5357450" y="8826946"/>
            <a:ext cx="1539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.Figure</a:t>
            </a:r>
            <a:r>
              <a:rPr lang="it-IT" b="1" dirty="0"/>
              <a:t> 4</a:t>
            </a:r>
            <a:endParaRPr lang="en-GB" b="1" dirty="0"/>
          </a:p>
        </p:txBody>
      </p:sp>
      <p:pic>
        <p:nvPicPr>
          <p:cNvPr id="4" name="Immagine 3">
            <a:extLst>
              <a:ext uri="{FF2B5EF4-FFF2-40B4-BE49-F238E27FC236}">
                <a16:creationId xmlns="" xmlns:a16="http://schemas.microsoft.com/office/drawing/2014/main" id="{594DEEB9-F19E-1043-EDC4-DA031E06CCBC}"/>
              </a:ext>
            </a:extLst>
          </p:cNvPr>
          <p:cNvPicPr>
            <a:picLocks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38025" y="260879"/>
            <a:ext cx="2520000" cy="8820000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="" xmlns:a16="http://schemas.microsoft.com/office/drawing/2014/main" id="{C5907BBF-81AE-4FFF-5D4E-79472917330B}"/>
              </a:ext>
            </a:extLst>
          </p:cNvPr>
          <p:cNvPicPr>
            <a:picLocks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420268" y="254818"/>
            <a:ext cx="2520000" cy="88200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4624" y="2483768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/>
                <a:cs typeface="Helvetica"/>
              </a:rPr>
              <a:t>C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4365104" y="539552"/>
            <a:ext cx="2043668" cy="1092324"/>
            <a:chOff x="116632" y="1043608"/>
            <a:chExt cx="2043668" cy="1092324"/>
          </a:xfrm>
        </p:grpSpPr>
        <p:sp>
          <p:nvSpPr>
            <p:cNvPr id="6" name="TextBox 5"/>
            <p:cNvSpPr txBox="1"/>
            <p:nvPr/>
          </p:nvSpPr>
          <p:spPr>
            <a:xfrm>
              <a:off x="476672" y="1043608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Helvetica"/>
                  <a:cs typeface="Helvetica"/>
                </a:rPr>
                <a:t>CD8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628800" y="1043608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Helvetica"/>
                  <a:cs typeface="Helvetica"/>
                </a:rPr>
                <a:t>CD4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116632" y="1259632"/>
              <a:ext cx="891540" cy="876300"/>
              <a:chOff x="116632" y="1259632"/>
              <a:chExt cx="891540" cy="876300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116632" y="1259632"/>
                <a:ext cx="891540" cy="876300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 rot="16200000">
                <a:off x="-68034" y="1516306"/>
                <a:ext cx="56938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% of Max</a:t>
                </a: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1268760" y="1259632"/>
              <a:ext cx="891540" cy="876300"/>
              <a:chOff x="1268760" y="1259632"/>
              <a:chExt cx="891540" cy="876300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1268760" y="1259632"/>
                <a:ext cx="891540" cy="876300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 rot="16200000">
                <a:off x="1100063" y="1516307"/>
                <a:ext cx="56938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% of Max</a:t>
                </a:r>
              </a:p>
            </p:txBody>
          </p:sp>
        </p:grpSp>
      </p:grpSp>
      <p:grpSp>
        <p:nvGrpSpPr>
          <p:cNvPr id="16" name="Group 15"/>
          <p:cNvGrpSpPr/>
          <p:nvPr/>
        </p:nvGrpSpPr>
        <p:grpSpPr>
          <a:xfrm>
            <a:off x="44624" y="3083835"/>
            <a:ext cx="1001648" cy="876300"/>
            <a:chOff x="116632" y="4211960"/>
            <a:chExt cx="1001648" cy="876300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37840" y="4211960"/>
              <a:ext cx="980440" cy="876300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 rot="16200000">
              <a:off x="-68034" y="4468633"/>
              <a:ext cx="5693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% of Max</a:t>
              </a:r>
            </a:p>
          </p:txBody>
        </p:sp>
      </p:grpSp>
      <p:grpSp>
        <p:nvGrpSpPr>
          <p:cNvPr id="76" name="Group 75"/>
          <p:cNvGrpSpPr/>
          <p:nvPr/>
        </p:nvGrpSpPr>
        <p:grpSpPr>
          <a:xfrm>
            <a:off x="980728" y="3083835"/>
            <a:ext cx="1036479" cy="876300"/>
            <a:chOff x="1356737" y="3083835"/>
            <a:chExt cx="1036479" cy="876300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412776" y="3083835"/>
              <a:ext cx="980440" cy="876300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 rot="16200000">
              <a:off x="1172071" y="3340509"/>
              <a:ext cx="5693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% of Max</a:t>
              </a: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44624" y="4115950"/>
            <a:ext cx="969898" cy="876300"/>
            <a:chOff x="116632" y="5580112"/>
            <a:chExt cx="969898" cy="876300"/>
          </a:xfrm>
        </p:grpSpPr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169590" y="5580112"/>
              <a:ext cx="916940" cy="876300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 rot="16200000">
              <a:off x="-68034" y="5836786"/>
              <a:ext cx="5693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% of Max</a:t>
              </a: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1036767" y="4115950"/>
            <a:ext cx="948690" cy="876300"/>
            <a:chOff x="1268760" y="5580112"/>
            <a:chExt cx="948690" cy="876300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300510" y="5580112"/>
              <a:ext cx="916940" cy="876300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 rot="16200000">
              <a:off x="1084094" y="5836786"/>
              <a:ext cx="5693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% of Max</a:t>
              </a:r>
            </a:p>
          </p:txBody>
        </p:sp>
      </p:grpSp>
      <p:sp>
        <p:nvSpPr>
          <p:cNvPr id="29" name="CasellaDiTesto 5"/>
          <p:cNvSpPr txBox="1"/>
          <p:nvPr/>
        </p:nvSpPr>
        <p:spPr>
          <a:xfrm>
            <a:off x="5157192" y="8774668"/>
            <a:ext cx="15927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Suppl. Figure 5</a:t>
            </a:r>
            <a:endParaRPr lang="en-GB" b="1" dirty="0"/>
          </a:p>
        </p:txBody>
      </p:sp>
      <p:grpSp>
        <p:nvGrpSpPr>
          <p:cNvPr id="42" name="Group 41"/>
          <p:cNvGrpSpPr/>
          <p:nvPr/>
        </p:nvGrpSpPr>
        <p:grpSpPr>
          <a:xfrm>
            <a:off x="44624" y="5140444"/>
            <a:ext cx="947579" cy="876300"/>
            <a:chOff x="1212721" y="6228184"/>
            <a:chExt cx="947579" cy="876300"/>
          </a:xfrm>
        </p:grpSpPr>
        <p:sp>
          <p:nvSpPr>
            <p:cNvPr id="37" name="TextBox 36"/>
            <p:cNvSpPr txBox="1"/>
            <p:nvPr/>
          </p:nvSpPr>
          <p:spPr>
            <a:xfrm rot="16200000">
              <a:off x="1028055" y="6491535"/>
              <a:ext cx="5693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% of Max</a:t>
              </a:r>
            </a:p>
          </p:txBody>
        </p:sp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1268760" y="6228184"/>
              <a:ext cx="891540" cy="876300"/>
            </a:xfrm>
            <a:prstGeom prst="rect">
              <a:avLst/>
            </a:prstGeom>
          </p:spPr>
        </p:pic>
      </p:grpSp>
      <p:grpSp>
        <p:nvGrpSpPr>
          <p:cNvPr id="41" name="Group 40"/>
          <p:cNvGrpSpPr/>
          <p:nvPr/>
        </p:nvGrpSpPr>
        <p:grpSpPr>
          <a:xfrm>
            <a:off x="1021910" y="5140444"/>
            <a:ext cx="963547" cy="876300"/>
            <a:chOff x="2348881" y="6156176"/>
            <a:chExt cx="963547" cy="876300"/>
          </a:xfrm>
        </p:grpSpPr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2420888" y="6156176"/>
              <a:ext cx="891540" cy="876300"/>
            </a:xfrm>
            <a:prstGeom prst="rect">
              <a:avLst/>
            </a:prstGeom>
          </p:spPr>
        </p:pic>
        <p:sp>
          <p:nvSpPr>
            <p:cNvPr id="40" name="TextBox 39"/>
            <p:cNvSpPr txBox="1"/>
            <p:nvPr/>
          </p:nvSpPr>
          <p:spPr>
            <a:xfrm rot="16200000">
              <a:off x="2164215" y="6412850"/>
              <a:ext cx="5693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% of Max</a:t>
              </a: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-27384" y="743372"/>
            <a:ext cx="1047368" cy="876300"/>
            <a:chOff x="764704" y="539552"/>
            <a:chExt cx="1047368" cy="876300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836712" y="539552"/>
              <a:ext cx="975360" cy="876300"/>
            </a:xfrm>
            <a:prstGeom prst="rect">
              <a:avLst/>
            </a:prstGeom>
          </p:spPr>
        </p:pic>
        <p:sp>
          <p:nvSpPr>
            <p:cNvPr id="43" name="TextBox 42"/>
            <p:cNvSpPr txBox="1"/>
            <p:nvPr/>
          </p:nvSpPr>
          <p:spPr>
            <a:xfrm rot="16200000">
              <a:off x="631335" y="744929"/>
              <a:ext cx="4667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SSC-A</a:t>
              </a: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1168732" y="743372"/>
            <a:ext cx="1047368" cy="876300"/>
            <a:chOff x="1916832" y="539552"/>
            <a:chExt cx="1047368" cy="876300"/>
          </a:xfrm>
        </p:grpSpPr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1988840" y="539552"/>
              <a:ext cx="975360" cy="876300"/>
            </a:xfrm>
            <a:prstGeom prst="rect">
              <a:avLst/>
            </a:prstGeom>
          </p:spPr>
        </p:pic>
        <p:sp>
          <p:nvSpPr>
            <p:cNvPr id="44" name="TextBox 43"/>
            <p:cNvSpPr txBox="1"/>
            <p:nvPr/>
          </p:nvSpPr>
          <p:spPr>
            <a:xfrm rot="16200000">
              <a:off x="1787398" y="740994"/>
              <a:ext cx="4589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FSC-H</a:t>
              </a: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2364848" y="550148"/>
            <a:ext cx="970440" cy="1069524"/>
            <a:chOff x="3156936" y="323529"/>
            <a:chExt cx="970440" cy="1069524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3212976" y="395536"/>
              <a:ext cx="914400" cy="980440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 rot="16200000">
              <a:off x="2722202" y="758263"/>
              <a:ext cx="106952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APC-R700-A&gt;: CD4</a:t>
              </a:r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4077072" y="827584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80628" y="467544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060848" y="2483768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/>
                <a:cs typeface="Helvetica"/>
              </a:rPr>
              <a:t>D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404664" y="2843808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Helvetica"/>
                <a:cs typeface="Helvetica"/>
              </a:rPr>
              <a:t>CD8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370142" y="2843808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Helvetica"/>
                <a:cs typeface="Helvetica"/>
              </a:rPr>
              <a:t>CD4</a:t>
            </a:r>
          </a:p>
        </p:txBody>
      </p:sp>
      <p:grpSp>
        <p:nvGrpSpPr>
          <p:cNvPr id="77" name="Group 76"/>
          <p:cNvGrpSpPr/>
          <p:nvPr/>
        </p:nvGrpSpPr>
        <p:grpSpPr>
          <a:xfrm>
            <a:off x="2348881" y="2918525"/>
            <a:ext cx="992143" cy="1041610"/>
            <a:chOff x="2724889" y="2918525"/>
            <a:chExt cx="992143" cy="104161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2802632" y="3000015"/>
              <a:ext cx="914400" cy="960120"/>
            </a:xfrm>
            <a:prstGeom prst="rect">
              <a:avLst/>
            </a:prstGeom>
          </p:spPr>
        </p:pic>
        <p:sp>
          <p:nvSpPr>
            <p:cNvPr id="64" name="TextBox 63"/>
            <p:cNvSpPr txBox="1"/>
            <p:nvPr/>
          </p:nvSpPr>
          <p:spPr>
            <a:xfrm rot="16200000">
              <a:off x="2322215" y="3321199"/>
              <a:ext cx="10054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APC-Cy7-A&gt;: IFN</a:t>
              </a:r>
              <a:r>
                <a:rPr lang="en-US" sz="700" dirty="0">
                  <a:latin typeface="Symbol" charset="2"/>
                  <a:cs typeface="Symbol" charset="2"/>
                </a:rPr>
                <a:t>g</a:t>
              </a:r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2348880" y="5076056"/>
            <a:ext cx="992144" cy="940688"/>
            <a:chOff x="2724888" y="5148064"/>
            <a:chExt cx="992144" cy="940688"/>
          </a:xfrm>
        </p:grpSpPr>
        <p:pic>
          <p:nvPicPr>
            <p:cNvPr id="59" name="Picture 58"/>
            <p:cNvPicPr>
              <a:picLocks noChangeAspect="1"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2802632" y="5220072"/>
              <a:ext cx="914400" cy="868680"/>
            </a:xfrm>
            <a:prstGeom prst="rect">
              <a:avLst/>
            </a:prstGeom>
          </p:spPr>
        </p:pic>
        <p:sp>
          <p:nvSpPr>
            <p:cNvPr id="65" name="TextBox 64"/>
            <p:cNvSpPr txBox="1"/>
            <p:nvPr/>
          </p:nvSpPr>
          <p:spPr>
            <a:xfrm rot="16200000">
              <a:off x="2418394" y="5454558"/>
              <a:ext cx="81304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PE-A&gt;: GrnzB</a:t>
              </a:r>
              <a:endParaRPr lang="en-US" sz="7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79" name="Group 78"/>
          <p:cNvGrpSpPr/>
          <p:nvPr/>
        </p:nvGrpSpPr>
        <p:grpSpPr>
          <a:xfrm>
            <a:off x="2348880" y="3995937"/>
            <a:ext cx="992144" cy="996313"/>
            <a:chOff x="2724888" y="3995937"/>
            <a:chExt cx="992144" cy="996313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2802632" y="4095630"/>
              <a:ext cx="914400" cy="896620"/>
            </a:xfrm>
            <a:prstGeom prst="rect">
              <a:avLst/>
            </a:prstGeom>
          </p:spPr>
        </p:pic>
        <p:sp>
          <p:nvSpPr>
            <p:cNvPr id="66" name="TextBox 65"/>
            <p:cNvSpPr txBox="1"/>
            <p:nvPr/>
          </p:nvSpPr>
          <p:spPr>
            <a:xfrm rot="16200000">
              <a:off x="2388260" y="4332565"/>
              <a:ext cx="8733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BV505-A&gt;: PD1</a:t>
              </a:r>
              <a:endParaRPr lang="en-US" sz="7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78" name="Group 77"/>
          <p:cNvGrpSpPr/>
          <p:nvPr/>
        </p:nvGrpSpPr>
        <p:grpSpPr>
          <a:xfrm>
            <a:off x="3378696" y="2918525"/>
            <a:ext cx="986408" cy="1041610"/>
            <a:chOff x="3861048" y="2918525"/>
            <a:chExt cx="986408" cy="104161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3933056" y="3000015"/>
              <a:ext cx="914400" cy="960120"/>
            </a:xfrm>
            <a:prstGeom prst="rect">
              <a:avLst/>
            </a:prstGeom>
          </p:spPr>
        </p:pic>
        <p:sp>
          <p:nvSpPr>
            <p:cNvPr id="67" name="TextBox 66"/>
            <p:cNvSpPr txBox="1"/>
            <p:nvPr/>
          </p:nvSpPr>
          <p:spPr>
            <a:xfrm rot="16200000">
              <a:off x="3458374" y="3321199"/>
              <a:ext cx="10054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APC-Cy7-A&gt;: IFN</a:t>
              </a:r>
              <a:r>
                <a:rPr lang="en-US" sz="700" dirty="0">
                  <a:latin typeface="Symbol" charset="2"/>
                  <a:cs typeface="Symbol" charset="2"/>
                </a:rPr>
                <a:t>g</a:t>
              </a:r>
            </a:p>
          </p:txBody>
        </p:sp>
      </p:grpSp>
      <p:grpSp>
        <p:nvGrpSpPr>
          <p:cNvPr id="83" name="Group 82"/>
          <p:cNvGrpSpPr/>
          <p:nvPr/>
        </p:nvGrpSpPr>
        <p:grpSpPr>
          <a:xfrm>
            <a:off x="4653137" y="2918525"/>
            <a:ext cx="1089392" cy="1041610"/>
            <a:chOff x="5301208" y="2918525"/>
            <a:chExt cx="1089392" cy="104161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17" cstate="print"/>
            <a:stretch>
              <a:fillRect/>
            </a:stretch>
          </p:blipFill>
          <p:spPr>
            <a:xfrm>
              <a:off x="5394920" y="3000015"/>
              <a:ext cx="995680" cy="960120"/>
            </a:xfrm>
            <a:prstGeom prst="rect">
              <a:avLst/>
            </a:prstGeom>
          </p:spPr>
        </p:pic>
        <p:sp>
          <p:nvSpPr>
            <p:cNvPr id="68" name="TextBox 67"/>
            <p:cNvSpPr txBox="1"/>
            <p:nvPr/>
          </p:nvSpPr>
          <p:spPr>
            <a:xfrm rot="16200000">
              <a:off x="4898534" y="3321199"/>
              <a:ext cx="10054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APC-Cy7-A&gt;: IFN</a:t>
              </a:r>
              <a:r>
                <a:rPr lang="en-US" sz="700" dirty="0">
                  <a:latin typeface="Symbol" charset="2"/>
                  <a:cs typeface="Symbol" charset="2"/>
                </a:rPr>
                <a:t>g</a:t>
              </a:r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5677217" y="2918525"/>
            <a:ext cx="1051719" cy="1041610"/>
            <a:chOff x="6469305" y="2918525"/>
            <a:chExt cx="1051719" cy="1041610"/>
          </a:xfrm>
        </p:grpSpPr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6525344" y="3000015"/>
              <a:ext cx="995680" cy="960120"/>
            </a:xfrm>
            <a:prstGeom prst="rect">
              <a:avLst/>
            </a:prstGeom>
          </p:spPr>
        </p:pic>
        <p:sp>
          <p:nvSpPr>
            <p:cNvPr id="69" name="TextBox 68"/>
            <p:cNvSpPr txBox="1"/>
            <p:nvPr/>
          </p:nvSpPr>
          <p:spPr>
            <a:xfrm rot="16200000">
              <a:off x="6054502" y="3333328"/>
              <a:ext cx="102966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APC-Cy7-A&gt;: IFN</a:t>
              </a:r>
              <a:r>
                <a:rPr lang="en-US" sz="700" dirty="0">
                  <a:latin typeface="Symbol" charset="2"/>
                  <a:cs typeface="Symbol" charset="2"/>
                </a:rPr>
                <a:t>g</a:t>
              </a:r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3378696" y="3995937"/>
            <a:ext cx="986408" cy="996313"/>
            <a:chOff x="3861048" y="3995937"/>
            <a:chExt cx="986408" cy="996313"/>
          </a:xfrm>
        </p:grpSpPr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9" cstate="print"/>
            <a:stretch>
              <a:fillRect/>
            </a:stretch>
          </p:blipFill>
          <p:spPr>
            <a:xfrm>
              <a:off x="3933056" y="4095630"/>
              <a:ext cx="914400" cy="896620"/>
            </a:xfrm>
            <a:prstGeom prst="rect">
              <a:avLst/>
            </a:prstGeom>
          </p:spPr>
        </p:pic>
        <p:sp>
          <p:nvSpPr>
            <p:cNvPr id="70" name="TextBox 69"/>
            <p:cNvSpPr txBox="1"/>
            <p:nvPr/>
          </p:nvSpPr>
          <p:spPr>
            <a:xfrm rot="16200000">
              <a:off x="3524420" y="4332565"/>
              <a:ext cx="8733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BV505-A&gt;: PD1</a:t>
              </a:r>
              <a:endParaRPr lang="en-US" sz="7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84" name="Group 83"/>
          <p:cNvGrpSpPr/>
          <p:nvPr/>
        </p:nvGrpSpPr>
        <p:grpSpPr>
          <a:xfrm>
            <a:off x="4653136" y="3995937"/>
            <a:ext cx="1089393" cy="996313"/>
            <a:chOff x="5301207" y="3995937"/>
            <a:chExt cx="1089393" cy="996313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5394920" y="4095630"/>
              <a:ext cx="995680" cy="896620"/>
            </a:xfrm>
            <a:prstGeom prst="rect">
              <a:avLst/>
            </a:prstGeom>
          </p:spPr>
        </p:pic>
        <p:sp>
          <p:nvSpPr>
            <p:cNvPr id="71" name="TextBox 70"/>
            <p:cNvSpPr txBox="1"/>
            <p:nvPr/>
          </p:nvSpPr>
          <p:spPr>
            <a:xfrm rot="16200000">
              <a:off x="4964579" y="4332565"/>
              <a:ext cx="8733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BV505-A&gt;: PD1</a:t>
              </a:r>
              <a:endParaRPr lang="en-US" sz="7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87" name="Group 86"/>
          <p:cNvGrpSpPr/>
          <p:nvPr/>
        </p:nvGrpSpPr>
        <p:grpSpPr>
          <a:xfrm>
            <a:off x="5677216" y="3995937"/>
            <a:ext cx="1051720" cy="996313"/>
            <a:chOff x="6469304" y="3995937"/>
            <a:chExt cx="1051720" cy="996313"/>
          </a:xfrm>
        </p:grpSpPr>
        <p:pic>
          <p:nvPicPr>
            <p:cNvPr id="55" name="Picture 54"/>
            <p:cNvPicPr>
              <a:picLocks noChangeAspect="1"/>
            </p:cNvPicPr>
            <p:nvPr/>
          </p:nvPicPr>
          <p:blipFill>
            <a:blip r:embed="rId21" cstate="print"/>
            <a:stretch>
              <a:fillRect/>
            </a:stretch>
          </p:blipFill>
          <p:spPr>
            <a:xfrm>
              <a:off x="6525344" y="4095630"/>
              <a:ext cx="995680" cy="896620"/>
            </a:xfrm>
            <a:prstGeom prst="rect">
              <a:avLst/>
            </a:prstGeom>
          </p:spPr>
        </p:pic>
        <p:sp>
          <p:nvSpPr>
            <p:cNvPr id="72" name="TextBox 71"/>
            <p:cNvSpPr txBox="1"/>
            <p:nvPr/>
          </p:nvSpPr>
          <p:spPr>
            <a:xfrm rot="16200000">
              <a:off x="6132676" y="4332565"/>
              <a:ext cx="8733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BV505-A&gt;: PD1</a:t>
              </a:r>
              <a:endParaRPr lang="en-US" sz="7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82" name="Group 81"/>
          <p:cNvGrpSpPr/>
          <p:nvPr/>
        </p:nvGrpSpPr>
        <p:grpSpPr>
          <a:xfrm>
            <a:off x="3378697" y="5076057"/>
            <a:ext cx="986407" cy="940687"/>
            <a:chOff x="3861049" y="5148065"/>
            <a:chExt cx="986407" cy="940687"/>
          </a:xfrm>
        </p:grpSpPr>
        <p:pic>
          <p:nvPicPr>
            <p:cNvPr id="60" name="Picture 59"/>
            <p:cNvPicPr>
              <a:picLocks noChangeAspect="1"/>
            </p:cNvPicPr>
            <p:nvPr/>
          </p:nvPicPr>
          <p:blipFill>
            <a:blip r:embed="rId22" cstate="print"/>
            <a:stretch>
              <a:fillRect/>
            </a:stretch>
          </p:blipFill>
          <p:spPr>
            <a:xfrm>
              <a:off x="3933056" y="5220072"/>
              <a:ext cx="914400" cy="868680"/>
            </a:xfrm>
            <a:prstGeom prst="rect">
              <a:avLst/>
            </a:prstGeom>
          </p:spPr>
        </p:pic>
        <p:sp>
          <p:nvSpPr>
            <p:cNvPr id="73" name="TextBox 72"/>
            <p:cNvSpPr txBox="1"/>
            <p:nvPr/>
          </p:nvSpPr>
          <p:spPr>
            <a:xfrm rot="16200000">
              <a:off x="3554555" y="5454559"/>
              <a:ext cx="81304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PE-A&gt;: GrnzB</a:t>
              </a:r>
              <a:endParaRPr lang="en-US" sz="7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85" name="Group 84"/>
          <p:cNvGrpSpPr/>
          <p:nvPr/>
        </p:nvGrpSpPr>
        <p:grpSpPr>
          <a:xfrm>
            <a:off x="4653137" y="5076057"/>
            <a:ext cx="1089392" cy="940687"/>
            <a:chOff x="5301208" y="5148065"/>
            <a:chExt cx="1089392" cy="940687"/>
          </a:xfrm>
        </p:grpSpPr>
        <p:pic>
          <p:nvPicPr>
            <p:cNvPr id="61" name="Picture 60"/>
            <p:cNvPicPr>
              <a:picLocks noChangeAspect="1"/>
            </p:cNvPicPr>
            <p:nvPr/>
          </p:nvPicPr>
          <p:blipFill>
            <a:blip r:embed="rId23" cstate="print"/>
            <a:stretch>
              <a:fillRect/>
            </a:stretch>
          </p:blipFill>
          <p:spPr>
            <a:xfrm>
              <a:off x="5394920" y="5220072"/>
              <a:ext cx="995680" cy="868680"/>
            </a:xfrm>
            <a:prstGeom prst="rect">
              <a:avLst/>
            </a:prstGeom>
          </p:spPr>
        </p:pic>
        <p:sp>
          <p:nvSpPr>
            <p:cNvPr id="74" name="TextBox 73"/>
            <p:cNvSpPr txBox="1"/>
            <p:nvPr/>
          </p:nvSpPr>
          <p:spPr>
            <a:xfrm rot="16200000">
              <a:off x="4994714" y="5454559"/>
              <a:ext cx="81304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PE-A&gt;: GrnzB</a:t>
              </a:r>
              <a:endParaRPr lang="en-US" sz="7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88" name="Group 87"/>
          <p:cNvGrpSpPr/>
          <p:nvPr/>
        </p:nvGrpSpPr>
        <p:grpSpPr>
          <a:xfrm>
            <a:off x="5677217" y="5076057"/>
            <a:ext cx="1051719" cy="940687"/>
            <a:chOff x="6469305" y="5148065"/>
            <a:chExt cx="1051719" cy="940687"/>
          </a:xfrm>
        </p:grpSpPr>
        <p:pic>
          <p:nvPicPr>
            <p:cNvPr id="62" name="Picture 61"/>
            <p:cNvPicPr>
              <a:picLocks noChangeAspect="1"/>
            </p:cNvPicPr>
            <p:nvPr/>
          </p:nvPicPr>
          <p:blipFill>
            <a:blip r:embed="rId24" cstate="print"/>
            <a:stretch>
              <a:fillRect/>
            </a:stretch>
          </p:blipFill>
          <p:spPr>
            <a:xfrm>
              <a:off x="6525344" y="5220072"/>
              <a:ext cx="995680" cy="868680"/>
            </a:xfrm>
            <a:prstGeom prst="rect">
              <a:avLst/>
            </a:prstGeom>
          </p:spPr>
        </p:pic>
        <p:sp>
          <p:nvSpPr>
            <p:cNvPr id="75" name="TextBox 74"/>
            <p:cNvSpPr txBox="1"/>
            <p:nvPr/>
          </p:nvSpPr>
          <p:spPr>
            <a:xfrm rot="16200000">
              <a:off x="6162811" y="5454559"/>
              <a:ext cx="81304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&lt;PE-A&gt;: GrnzB</a:t>
              </a:r>
              <a:endParaRPr lang="en-US" sz="700" dirty="0">
                <a:latin typeface="Symbol" charset="2"/>
                <a:cs typeface="Symbol" charset="2"/>
              </a:endParaRPr>
            </a:p>
          </p:txBody>
        </p:sp>
      </p:grpSp>
      <p:sp>
        <p:nvSpPr>
          <p:cNvPr id="89" name="TextBox 88"/>
          <p:cNvSpPr txBox="1"/>
          <p:nvPr/>
        </p:nvSpPr>
        <p:spPr>
          <a:xfrm>
            <a:off x="3212976" y="2555776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Helvetica"/>
                <a:cs typeface="Helvetica"/>
              </a:rPr>
              <a:t>CD8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5589240" y="2555776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Helvetica"/>
                <a:cs typeface="Helvetica"/>
              </a:rPr>
              <a:t>CD4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2708920" y="2859197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Helvetica"/>
                <a:cs typeface="Helvetica"/>
              </a:rPr>
              <a:t>Sample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3789040" y="2859197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Helvetica"/>
                <a:cs typeface="Helvetica"/>
              </a:rPr>
              <a:t>FMO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5013176" y="2859197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Helvetica"/>
                <a:cs typeface="Helvetica"/>
              </a:rPr>
              <a:t>Sample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6093296" y="2859197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Helvetica"/>
                <a:cs typeface="Helvetica"/>
              </a:rPr>
              <a:t>FMO</a:t>
            </a:r>
          </a:p>
        </p:txBody>
      </p:sp>
    </p:spTree>
    <p:extLst>
      <p:ext uri="{BB962C8B-B14F-4D97-AF65-F5344CB8AC3E}">
        <p14:creationId xmlns:p14="http://schemas.microsoft.com/office/powerpoint/2010/main" xmlns="" val="3085382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7"/>
          <p:cNvSpPr txBox="1"/>
          <p:nvPr/>
        </p:nvSpPr>
        <p:spPr>
          <a:xfrm>
            <a:off x="5273531" y="8739172"/>
            <a:ext cx="1539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.Figure</a:t>
            </a:r>
            <a:r>
              <a:rPr lang="it-IT" b="1" dirty="0"/>
              <a:t> 6</a:t>
            </a:r>
            <a:endParaRPr lang="en-GB" b="1" dirty="0"/>
          </a:p>
        </p:txBody>
      </p:sp>
      <p:pic>
        <p:nvPicPr>
          <p:cNvPr id="4" name="Picture 4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08720" y="1475656"/>
            <a:ext cx="2257200" cy="196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5"/>
          <p:cNvPicPr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08720" y="3131840"/>
            <a:ext cx="2257200" cy="196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6"/>
          <p:cNvPicPr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908720" y="4798536"/>
            <a:ext cx="2257200" cy="196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9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908104" y="1475656"/>
            <a:ext cx="2257200" cy="196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10"/>
          <p:cNvPicPr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908104" y="3131840"/>
            <a:ext cx="2257200" cy="196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11"/>
          <p:cNvPicPr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908104" y="4798536"/>
            <a:ext cx="2257200" cy="196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CasellaDiTesto 16"/>
          <p:cNvSpPr txBox="1"/>
          <p:nvPr/>
        </p:nvSpPr>
        <p:spPr>
          <a:xfrm>
            <a:off x="1772816" y="1043608"/>
            <a:ext cx="969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/>
              <a:t>CD8</a:t>
            </a:r>
          </a:p>
        </p:txBody>
      </p:sp>
      <p:sp>
        <p:nvSpPr>
          <p:cNvPr id="11" name="CasellaDiTesto 16"/>
          <p:cNvSpPr txBox="1"/>
          <p:nvPr/>
        </p:nvSpPr>
        <p:spPr>
          <a:xfrm>
            <a:off x="4628184" y="1115616"/>
            <a:ext cx="969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/>
              <a:t>CD4</a:t>
            </a:r>
          </a:p>
        </p:txBody>
      </p:sp>
      <p:cxnSp>
        <p:nvCxnSpPr>
          <p:cNvPr id="12" name="Straight Connector 26">
            <a:extLst>
              <a:ext uri="{FF2B5EF4-FFF2-40B4-BE49-F238E27FC236}">
                <a16:creationId xmlns="" xmlns:a16="http://schemas.microsoft.com/office/drawing/2014/main" id="{45C04108-9B2C-6C45-8DF3-D305A552594D}"/>
              </a:ext>
            </a:extLst>
          </p:cNvPr>
          <p:cNvCxnSpPr>
            <a:cxnSpLocks/>
          </p:cNvCxnSpPr>
          <p:nvPr/>
        </p:nvCxnSpPr>
        <p:spPr>
          <a:xfrm flipH="1">
            <a:off x="3356992" y="808428"/>
            <a:ext cx="23811" cy="6931924"/>
          </a:xfrm>
          <a:prstGeom prst="line">
            <a:avLst/>
          </a:prstGeom>
          <a:ln w="19050" cmpd="sng">
            <a:solidFill>
              <a:schemeClr val="tx1"/>
            </a:solidFill>
            <a:prstDash val="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6762592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4</TotalTime>
  <Words>156</Words>
  <Application>Microsoft Office PowerPoint</Application>
  <PresentationFormat>Presentazione su schermo (4:3)</PresentationFormat>
  <Paragraphs>89</Paragraphs>
  <Slides>6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6</vt:i4>
      </vt:variant>
    </vt:vector>
  </HeadingPairs>
  <TitlesOfParts>
    <vt:vector size="7" baseType="lpstr">
      <vt:lpstr>Tema di Office</vt:lpstr>
      <vt:lpstr>Diapositiva 1</vt:lpstr>
      <vt:lpstr>Diapositiva 2</vt:lpstr>
      <vt:lpstr>Diapositiva 3</vt:lpstr>
      <vt:lpstr>Diapositiva 4</vt:lpstr>
      <vt:lpstr>Diapositiva 5</vt:lpstr>
      <vt:lpstr>Diapositiva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ortunatoorazio</dc:creator>
  <cp:lastModifiedBy>fortunatoorazio</cp:lastModifiedBy>
  <cp:revision>121</cp:revision>
  <cp:lastPrinted>2022-08-19T13:12:30Z</cp:lastPrinted>
  <dcterms:created xsi:type="dcterms:W3CDTF">2022-03-08T08:19:12Z</dcterms:created>
  <dcterms:modified xsi:type="dcterms:W3CDTF">2022-08-23T07:24:57Z</dcterms:modified>
</cp:coreProperties>
</file>